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7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FD93F-AA92-4204-9CE5-CFD9ED1430AE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AC019E-D9F8-4244-A3CC-4F4F4C58370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661526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AC019E-D9F8-4244-A3CC-4F4F4C583701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9897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EDAAE0-14B5-42AD-B452-24489A589D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DC895E-E982-4FA0-BE11-1563E56EDC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12D794-6501-49CF-9654-94BE412D2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6906EF-1600-4193-8BA7-EC97CA09C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64965F-23AC-4A1C-A5ED-6D2508776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48967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462D77-A76D-4B87-A6F7-DE11852B8C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D9E3EB-B3D5-4794-B074-451D437DC9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6AF584-DD77-42B2-BE58-FE12DF211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1EEC0F-68BA-4C0B-9697-15095BAF9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81194A-A42E-4C31-B9C4-53B35F4D8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9958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9559C4-4079-4681-A8ED-5B67A8DE3F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FC5F9C-C1D4-46B5-8B0C-1BF17448F3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76A62A-BED3-463F-B1E7-61A68A4DF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13ADD0-D8B3-463D-AEF4-8B63685AD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55C324-DA26-4FE2-9D5A-E424A0422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31304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B72A7-9833-42FA-B45C-D6E8C83DBC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B7A01A-CFDC-49EE-87E3-5343F2FD8E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64B398-71AD-4B7C-ABEE-FD8F67880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A9F0AB-47A4-4171-8CA5-BC8455E79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EC148E-ADCC-4731-B420-26449CE1B0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0010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91D4C8-78B0-426A-A70E-93A045FE0B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DBD68D-FBD7-469B-8669-9D3A3EEE4F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8CD315-AFC2-45E4-B355-3A7637161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3AC63B-12E4-4914-978F-2C45BB449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7045D7-B7D3-4F47-9AFE-DA1F759B4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5191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B56E2A-3B09-4C31-B781-CAEECB4F2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ED92E1-7466-4D4D-8AED-D6343C0BA1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C6459D-0E41-4CC0-94C7-E4C96B2384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DA9E96-1325-40BF-8262-5B40B2890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E1A520-69A1-4776-BD55-5E9231EED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1F84D2-5DB1-49C1-BE61-9FC64DC4D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99924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3649AB-E2CE-4CF5-B7CB-1D4A87A767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61AE81-3039-4A0E-B207-DDA769EB28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94CA42-C59B-4A5C-920F-F7E5F4987F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BD0036-AF63-46B4-85BA-A9DB5B8A11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EC1A76D-D1F7-4334-AA0B-7BCF378578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0FB5E4-AA88-4F45-BECA-2FBB6042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5B9FF3-34D8-4D4B-9464-80C7858C5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36BEDE2-38F2-4FA4-9F43-ACA7DE8CC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9811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4898DA-4F90-4BAD-A28B-D215044A9E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EC57C9-5127-43BE-9868-501183BA4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9F8AB6-0A62-45B6-9C52-F70A692EC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D645CC-2699-44CC-A221-DDC4E6F98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46811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42901A-90B0-4DB7-B743-9E044CB90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17F047-076B-467F-9819-4337D5C01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8DE95C6-BAC0-4672-9D6F-7760063B0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73079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037E9-160A-4812-8A80-729D007BAC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FA8A17-F20E-47FA-9524-7F6D9F48DD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143DD-7370-46A8-B625-D90EC2A8DE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41C2A1-F46C-406D-B719-5EC7DBFD4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CE33DF-BCC7-4EE3-8B1A-1D6AA4D5D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19EED0-A99B-453A-A201-64E635F822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3452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1AB74-DDC4-4059-BD2B-B13A57E0B3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06B697-95DC-42E1-AA6A-48597BA588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07D463-B22A-43BB-BDA7-5227780C6F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E81E12-6C8E-4F26-8E37-DBC4F8971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0934D7-B8C9-4B19-A1B6-5218729E8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5F67B9-2591-4C80-8A88-4D06F75EE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66809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015DCBB-CD8B-4B2F-A9E3-DC0E6A5406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08C15E-B696-4B87-9471-3DEE5D7213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472A37-23C0-4728-9583-36FEFDFBD5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3DF94C-65D1-43FF-8ECA-F18E4CB07C76}" type="datetimeFigureOut">
              <a:rPr lang="en-IN" smtClean="0"/>
              <a:t>20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C1C5C2-BDBC-4906-AFB7-504EC60359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A66F67-ED72-432E-956E-C03E02ACA1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C113AF-E1F0-4399-BB3E-6DF2DA81E4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86869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5A8078C-083C-4C10-8E3D-BA2B90D3E9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230" y="647114"/>
            <a:ext cx="9853579" cy="367963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9BAED3A-F147-4791-8C17-8396976BA828}"/>
              </a:ext>
            </a:extLst>
          </p:cNvPr>
          <p:cNvSpPr txBox="1"/>
          <p:nvPr/>
        </p:nvSpPr>
        <p:spPr>
          <a:xfrm>
            <a:off x="695230" y="4509186"/>
            <a:ext cx="98535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1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&amp;E stain of the liver in the therapeutic model of OVX group fed with HFD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llow Arrow-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 Inflammation around the portal 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ad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bjective lens, ×10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ue arrow-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crosteatosis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steatosis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dilation of sinusoid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bjective lens ×40). 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75605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54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E</dc:creator>
  <cp:lastModifiedBy>Yogendra Nayak [MAHE-MCOPS]</cp:lastModifiedBy>
  <cp:revision>5</cp:revision>
  <dcterms:created xsi:type="dcterms:W3CDTF">2022-08-19T12:48:58Z</dcterms:created>
  <dcterms:modified xsi:type="dcterms:W3CDTF">2022-08-20T10:40:03Z</dcterms:modified>
</cp:coreProperties>
</file>